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2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6902"/>
    <p:restoredTop sz="95827"/>
  </p:normalViewPr>
  <p:slideViewPr>
    <p:cSldViewPr snapToGrid="0" snapToObjects="1">
      <p:cViewPr varScale="1">
        <p:scale>
          <a:sx n="107" d="100"/>
          <a:sy n="107" d="100"/>
        </p:scale>
        <p:origin x="6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E24AC3-525F-7143-8748-936305EF12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EA8A92A-2070-1440-BCAB-CE84B2B662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41BB36-9BCB-974D-B12B-461CDB3C9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47A8A-1CC0-BF41-A726-E678D5CD44D7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5B059F-0A4D-AF4A-97D9-D1B6051F8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A03226D-B3B3-194B-94B8-4B146192B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04379-445F-3644-9919-93B3B420B00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85538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11D819-EA35-0D48-83B8-950C76331C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DDDE5E5-4C15-5845-8D10-0E6BE378D0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5FD49AA-7A20-2744-A074-446DDDB01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47A8A-1CC0-BF41-A726-E678D5CD44D7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EBC537-2818-D146-83B4-911CE7E34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D2660B-8A08-CB4D-A6F2-E43A4DDBDD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04379-445F-3644-9919-93B3B420B00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74873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A2F5275-A4AA-7243-AC0B-1B3F6B6777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4C3B422-C69E-4F4D-AA21-3390543BDC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09BAE9F-687D-2448-A69C-3BD038661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47A8A-1CC0-BF41-A726-E678D5CD44D7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CFCA98-9C9F-E74D-9A16-6E162C6F0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DCC4E82-CEEA-584D-9014-F422CDE82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04379-445F-3644-9919-93B3B420B00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72895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997F76-C102-6349-B0DA-388FD1909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2578DEE-6D30-174E-88A1-13572C3672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78BC83-4E53-9847-BF06-003D1053A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47A8A-1CC0-BF41-A726-E678D5CD44D7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925FDC-23FB-FE43-99E1-00D48FF4B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74BBA63-2D9B-E54B-998A-2E2B3E104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04379-445F-3644-9919-93B3B420B00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47211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1403B1-C1C7-3241-8811-7C70C27328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55E95EB-FF1D-E740-B3CA-05DA0E0075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E86AF47-8499-A44E-A777-E79793BE8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47A8A-1CC0-BF41-A726-E678D5CD44D7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3A9D62-DBFC-1441-8C5B-FCE02AB96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EDC6BB-94F3-D644-A0C7-E2652C96B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04379-445F-3644-9919-93B3B420B00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03202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242626-8155-BB46-82B8-DA1168D41D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55BC3FD-20A1-454C-8B7F-7596DB62CF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E65C3E0-6714-D744-A081-AEB96D5A74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D29D2CA-C49E-114C-ABE2-E430B2F59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47A8A-1CC0-BF41-A726-E678D5CD44D7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2F853ED-3EA7-3946-84BE-941D473EE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FA6B155-EBAB-6349-BF8B-895ABEDEC2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04379-445F-3644-9919-93B3B420B00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69082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9887C5-689E-7741-98EF-507BB74E68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875A667-577F-3645-B159-C82C7A9364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D68703E-C77A-6440-BF2C-D99F642ED9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B9261FD-4C6B-7945-94AC-8429114816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34332A6-212A-424E-91F9-586A1EFA33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FF8FC03-A6D1-5B41-A4FD-92C2FF14B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47A8A-1CC0-BF41-A726-E678D5CD44D7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AC425F9-0F4A-9D4E-BA92-51B583557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F9D1601-93A3-904B-8FE0-FFEC9EF5D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04379-445F-3644-9919-93B3B420B00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69152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678476-4B16-394E-8986-1228E0D0A8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6CCAA08-2C52-E144-A153-A54DF6E4A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47A8A-1CC0-BF41-A726-E678D5CD44D7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941AB1A-0219-FD47-9F25-8D3E74504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3B8A818-3037-DC46-AF83-893BA29E7A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04379-445F-3644-9919-93B3B420B00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51658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93C0EB2-92AD-6144-8654-6882610C5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47A8A-1CC0-BF41-A726-E678D5CD44D7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BD99398-1D28-BF40-A1A0-F07AFF881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E7E930B-8799-B84C-AC33-271D1AA36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04379-445F-3644-9919-93B3B420B00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8693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5BA799-1882-A040-A79C-8E25F4A35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A5C320A-24A7-A244-A184-847B2F64CA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631099-FBE8-FB41-A0F2-6782F2ADA8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F3CAB31-7DAC-CF44-9DC7-61D243896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47A8A-1CC0-BF41-A726-E678D5CD44D7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64DA1DC-EB02-FF43-8600-C9E8604482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83BE83B-2656-B240-9B98-6F1DD10E6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04379-445F-3644-9919-93B3B420B00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08951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18C043-2E4F-5B43-8429-6CDDDD2984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B6AE28B-0F14-0B44-9272-566B5880D9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529404B-BE5C-6148-AADE-516CC25014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FC73E2C-06AD-204C-A651-E391DC130B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47A8A-1CC0-BF41-A726-E678D5CD44D7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01CA4E9-405E-544F-A5E8-7C9D693B0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78AEBBE-B568-9F4A-BA77-325A76F465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04379-445F-3644-9919-93B3B420B00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45916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C8A93DC-567B-454E-9BDF-70BEC133AF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6A306D2-7E2E-6743-9F8A-3057661687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0E0AF9-2B7C-F04B-BCE6-6872961442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247A8A-1CC0-BF41-A726-E678D5CD44D7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90532D-65A5-224D-A89E-42F0B08D27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026A8B-7911-7741-89A1-C33B0A6003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C04379-445F-3644-9919-93B3B420B00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7792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hyperlink" Target="http://www.mbkbase.org/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1059002" y="213758"/>
            <a:ext cx="10073996" cy="5580802"/>
            <a:chOff x="683722" y="544926"/>
            <a:chExt cx="10831011" cy="6116323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E1CB44B4-A6AD-81E4-D684-52DB6BB6E69E}"/>
                </a:ext>
              </a:extLst>
            </p:cNvPr>
            <p:cNvGrpSpPr/>
            <p:nvPr/>
          </p:nvGrpSpPr>
          <p:grpSpPr>
            <a:xfrm>
              <a:off x="683722" y="1070439"/>
              <a:ext cx="10831011" cy="5590810"/>
              <a:chOff x="387553" y="325593"/>
              <a:chExt cx="10831011" cy="5590810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E6536439-BDEB-205A-321C-E181BBF5A1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18564" y="325593"/>
                <a:ext cx="10800000" cy="1664931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C3521B17-5827-90D2-1B07-7243A23372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68147" r="2805" b="2881"/>
              <a:stretch/>
            </p:blipFill>
            <p:spPr>
              <a:xfrm>
                <a:off x="404502" y="1978123"/>
                <a:ext cx="10548000" cy="504597"/>
              </a:xfrm>
              <a:prstGeom prst="rect">
                <a:avLst/>
              </a:prstGeom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7BBDB902-348B-3223-2A3C-306D8DFC326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70256" r="2156" b="2862"/>
              <a:stretch/>
            </p:blipFill>
            <p:spPr>
              <a:xfrm>
                <a:off x="387553" y="2478963"/>
                <a:ext cx="10594800" cy="487392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6289150E-E0D3-7BEE-A5ED-C1441E8704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69679" r="2631" b="1808"/>
              <a:stretch/>
            </p:blipFill>
            <p:spPr>
              <a:xfrm>
                <a:off x="415676" y="2978412"/>
                <a:ext cx="10519200" cy="500837"/>
              </a:xfrm>
              <a:prstGeom prst="rect">
                <a:avLst/>
              </a:prstGeom>
            </p:spPr>
          </p:pic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A11CE039-1BFF-93BF-55AB-C3962BAE5C2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71234" r="2680" b="2703"/>
              <a:stretch/>
            </p:blipFill>
            <p:spPr>
              <a:xfrm>
                <a:off x="431442" y="3494350"/>
                <a:ext cx="10510550" cy="440440"/>
              </a:xfrm>
              <a:prstGeom prst="rect">
                <a:avLst/>
              </a:prstGeom>
            </p:spPr>
          </p:pic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4E7D8060-7B9C-8925-CA76-1C83B5A1EDF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71155" r="2680" b="1479"/>
              <a:stretch/>
            </p:blipFill>
            <p:spPr>
              <a:xfrm>
                <a:off x="431442" y="3976024"/>
                <a:ext cx="10510550" cy="461193"/>
              </a:xfrm>
              <a:prstGeom prst="rect">
                <a:avLst/>
              </a:prstGeom>
            </p:spPr>
          </p:pic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BE127218-11F4-86B2-ADCE-E8677FE93A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t="71187" r="2583" b="-347"/>
              <a:stretch/>
            </p:blipFill>
            <p:spPr>
              <a:xfrm>
                <a:off x="426187" y="4433299"/>
                <a:ext cx="10515600" cy="506128"/>
              </a:xfrm>
              <a:prstGeom prst="rect">
                <a:avLst/>
              </a:prstGeom>
            </p:spPr>
          </p:pic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D60E264F-8646-3F01-066F-3D6514F7848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t="70997" r="2309" b="782"/>
              <a:stretch/>
            </p:blipFill>
            <p:spPr>
              <a:xfrm>
                <a:off x="436697" y="4945228"/>
                <a:ext cx="10508401" cy="484946"/>
              </a:xfrm>
              <a:prstGeom prst="rect">
                <a:avLst/>
              </a:prstGeom>
            </p:spPr>
          </p:pic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9920CA32-2AA8-DB11-CB7A-9D6FA11338E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t="70772" r="2814" b="1748"/>
              <a:stretch/>
            </p:blipFill>
            <p:spPr>
              <a:xfrm>
                <a:off x="396863" y="5439420"/>
                <a:ext cx="10533600" cy="476983"/>
              </a:xfrm>
              <a:prstGeom prst="rect">
                <a:avLst/>
              </a:prstGeom>
            </p:spPr>
          </p:pic>
        </p:grpSp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B74D5409-A71A-CF0B-B43F-6FD6483F05C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022217" y="544926"/>
              <a:ext cx="6120000" cy="429760"/>
            </a:xfrm>
            <a:prstGeom prst="rect">
              <a:avLst/>
            </a:prstGeom>
          </p:spPr>
        </p:pic>
      </p:grpSp>
      <p:sp>
        <p:nvSpPr>
          <p:cNvPr id="25" name="文本框 24">
            <a:extLst>
              <a:ext uri="{FF2B5EF4-FFF2-40B4-BE49-F238E27FC236}">
                <a16:creationId xmlns:a16="http://schemas.microsoft.com/office/drawing/2014/main" id="{6FEF7726-AB1E-9918-8635-03856EE3C543}"/>
              </a:ext>
            </a:extLst>
          </p:cNvPr>
          <p:cNvSpPr txBox="1"/>
          <p:nvPr/>
        </p:nvSpPr>
        <p:spPr>
          <a:xfrm>
            <a:off x="946673" y="5905421"/>
            <a:ext cx="10298654" cy="9079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pattern of candidate genes of </a:t>
            </a:r>
            <a:r>
              <a:rPr lang="zh-CN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R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B</a:t>
            </a:r>
            <a:r>
              <a:rPr lang="zh-CN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profiles in various tissues at different developmental ages or cells, and the data were obtained from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12"/>
              </a:rPr>
              <a:t>http://www.mbkbase.org/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PKM, Fragments Per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lobas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Million, indicates gene expression level. Milk, filling and mature represent the developmental stages of rice grain. G-ale indicates grain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euron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-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cates grain embryo and g-ES indicates grain endosperm.</a:t>
            </a:r>
          </a:p>
        </p:txBody>
      </p:sp>
    </p:spTree>
    <p:extLst>
      <p:ext uri="{BB962C8B-B14F-4D97-AF65-F5344CB8AC3E}">
        <p14:creationId xmlns:p14="http://schemas.microsoft.com/office/powerpoint/2010/main" val="82413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9</Words>
  <Application>Microsoft Macintosh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4</cp:revision>
  <dcterms:created xsi:type="dcterms:W3CDTF">2022-07-23T07:51:18Z</dcterms:created>
  <dcterms:modified xsi:type="dcterms:W3CDTF">2022-07-30T12:39:53Z</dcterms:modified>
</cp:coreProperties>
</file>